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147375471" r:id="rId2"/>
    <p:sldId id="214737547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DDC00CA-3752-46B7-BF1D-5BC8A1D062BF}" v="87" dt="2025-02-11T13:57:13.79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030" autoAdjust="0"/>
  </p:normalViewPr>
  <p:slideViewPr>
    <p:cSldViewPr snapToGrid="0">
      <p:cViewPr varScale="1">
        <p:scale>
          <a:sx n="97" d="100"/>
          <a:sy n="97" d="100"/>
        </p:scale>
        <p:origin x="9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BAC362-39EE-4B53-A133-6E55F61C40F4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A37DF5-A442-405E-B0DC-2AC8D7294D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2676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1D16DD-DC12-3674-4C7B-3AB0D1F6BD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DAD69465-2016-91CC-8F45-5C20992DA64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E6300808-19C8-C2CD-7133-FB4E90F9690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51CB7DD-6D46-E3F9-80E0-A179C2F9BD2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13AF67-C78F-FF44-BD24-842064194C7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8041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715DEC-BEAB-D122-76D3-9F8C8D5A17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361BF6F-1ED2-3D29-0EF6-103C02FAA86C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4ED91A0-0117-94FE-C222-C6E8CFCBD4B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3F460A4-1EBA-96C3-2611-CA8056BEA8B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13AF67-C78F-FF44-BD24-842064194C73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603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A8EE82-477D-C0A3-A770-9DEA7AF890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F610714-C75B-59E3-36DD-B26DCF8D06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7338D1-C399-F5B3-3149-4B1DA255C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677599-231C-5D0D-FD45-CAC4841C1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7CEFDF-88E5-56A7-2B84-C7A6D36A4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3736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BDEC23-DC13-CA8D-BAB6-CC5A65279D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859B745-2226-9ECC-4382-1BA2FF2C7D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C8A0EE-FA1F-DFB6-4A71-86B6C6D88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D55F85-3179-BDD4-B7CB-C7C29498A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4CF114-E849-6E31-CEFA-95A7E309E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468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5B21B0C-F018-E50C-D5FA-E67FE0B700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77410A8-2283-46DC-BDA8-A5CE1D70F4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704469-1166-DFCA-0BC5-126A4EB13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553179-BE93-CE7C-4948-F80CDA013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178FE7-508F-CE4E-7A8F-4FAD7BC11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3171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07641F-BDF2-FD82-6C40-9877677D7A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247E03D-CD16-6F3B-EBAD-F003ADC607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EF2A45-9493-DB9B-EC9B-E75D3C527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930318-25B6-006A-8587-4BEF31414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955C71-442E-BD0C-013F-93445B08B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073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5A09D5-FE18-A9AD-68AA-4FAB201F37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61692D-0D72-0BBA-6BF9-E0C62C50F9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2FA32C-7A3A-799B-194E-6A258BC85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5DD378-F988-C326-7AE2-47DD14EA0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88C5A17-4856-6FA4-163D-385938D22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235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EA477A-E948-87A3-A23E-B75E12F2C8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F6E7D0C-C8A9-E0CC-0C76-D73288F74D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0B48CF5-4C50-8DC7-C2AC-A8036101EA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4B7A0E-28E7-673E-82E9-AB6ADC53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A5AF8E-2621-11ED-C9D3-80628208E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2E6AAA-6D8F-B0BF-9B1C-3DF74DEB5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6660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A3CFDA-2FF3-6C87-0754-687621CAC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B1DD408-29C4-75BE-FA9C-F421FB43AC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5FCB40-C5C6-B2FA-1165-4599ADD5F0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2D61968-D091-5CD3-A52D-EC53310AC1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9A9A41E-02AD-0950-3DDF-20C583E37E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555DB7D-073C-D43E-BFE6-18A5B8AFB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6CC4D9E-ADC9-9F3E-522D-8DBDCA638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C219B8B-7641-6179-B76B-EEE4A0980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17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8708C4-D6E7-7F4C-5A61-8F35F7DE5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BC57095-E981-1760-14EF-E0EDF5894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8CA316B-0637-4E6B-8516-0DA9880AB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4818D2A-0FDE-B62C-19A6-D76D56454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4098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0B62223-31B3-F2BF-03CE-AE6C2D380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BAF55C2-9BAF-4C56-1065-26C42A22A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96CE260-E93E-7D34-D93D-A5214BBE8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102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EC731D-48DD-D068-E74B-92599DBB91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CF82C14-ED3C-3943-BF01-6E9D58207C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B867E01-0842-44F8-82C3-8E4CF9E009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EF63A0-EEF5-AED2-B823-CA877768A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4AF379B-5177-1A0C-DD8F-82ACBB965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F4FC97C-DEA8-FFEB-3FCD-AB8ACD112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1590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9CED42-5A93-9189-42B4-16FA78D48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F02AEAD-7D6F-AB73-A21C-D496FB23CD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26F0E71-4021-EB74-5E9A-CFE61A0F9B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841974C-A37E-EF78-588E-6790E4949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51FEB5-BA04-1A86-DC10-A62A134B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66EC23-9925-0161-640A-F3F4D8793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815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16AC920-0A6E-8FB1-3C96-C82A5DF7F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9ED869-F421-3E70-519A-5471485974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53BDD1-D59E-6C5C-42C5-39C05A9A72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C39B76-E337-434C-9F0C-C1477C2A9B03}" type="datetimeFigureOut">
              <a:rPr kumimoji="1" lang="ja-JP" altLang="en-US" smtClean="0"/>
              <a:t>2025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4CAA62-CE83-7C8E-20A6-F592DAB32C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4503DB-8DE9-A560-4527-D77D26A2C1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EA860C-52DE-4170-8916-DE627D73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9294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74AA15-3F26-7480-C086-65F4451A6B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BA675059-49BA-AEFC-A082-B6D47EF0B3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1037929"/>
              </p:ext>
            </p:extLst>
          </p:nvPr>
        </p:nvGraphicFramePr>
        <p:xfrm>
          <a:off x="6047874" y="455052"/>
          <a:ext cx="6116648" cy="570581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63715">
                  <a:extLst>
                    <a:ext uri="{9D8B030D-6E8A-4147-A177-3AD203B41FA5}">
                      <a16:colId xmlns:a16="http://schemas.microsoft.com/office/drawing/2014/main" val="1592536099"/>
                    </a:ext>
                  </a:extLst>
                </a:gridCol>
                <a:gridCol w="2825512">
                  <a:extLst>
                    <a:ext uri="{9D8B030D-6E8A-4147-A177-3AD203B41FA5}">
                      <a16:colId xmlns:a16="http://schemas.microsoft.com/office/drawing/2014/main" val="1442593285"/>
                    </a:ext>
                  </a:extLst>
                </a:gridCol>
                <a:gridCol w="1033754">
                  <a:extLst>
                    <a:ext uri="{9D8B030D-6E8A-4147-A177-3AD203B41FA5}">
                      <a16:colId xmlns:a16="http://schemas.microsoft.com/office/drawing/2014/main" val="1841938356"/>
                    </a:ext>
                  </a:extLst>
                </a:gridCol>
                <a:gridCol w="627636">
                  <a:extLst>
                    <a:ext uri="{9D8B030D-6E8A-4147-A177-3AD203B41FA5}">
                      <a16:colId xmlns:a16="http://schemas.microsoft.com/office/drawing/2014/main" val="1469758428"/>
                    </a:ext>
                  </a:extLst>
                </a:gridCol>
                <a:gridCol w="627636">
                  <a:extLst>
                    <a:ext uri="{9D8B030D-6E8A-4147-A177-3AD203B41FA5}">
                      <a16:colId xmlns:a16="http://schemas.microsoft.com/office/drawing/2014/main" val="3231180097"/>
                    </a:ext>
                  </a:extLst>
                </a:gridCol>
                <a:gridCol w="738395">
                  <a:extLst>
                    <a:ext uri="{9D8B030D-6E8A-4147-A177-3AD203B41FA5}">
                      <a16:colId xmlns:a16="http://schemas.microsoft.com/office/drawing/2014/main" val="823368956"/>
                    </a:ext>
                  </a:extLst>
                </a:gridCol>
              </a:tblGrid>
              <a:tr h="43856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MSARS Part 2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 </a:t>
                      </a:r>
                    </a:p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q-value)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6182556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ial express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74 ± 0.8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34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15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462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392265558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26 ± 0.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1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54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047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16839510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ular motor dysfunct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21 ± 0.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1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55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924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79886662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or at rest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53 ± 0.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5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66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802341194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on tremor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37 ± 0.9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4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33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156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82759529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reased ton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8 ± 0.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1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649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74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142751687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pid alternating movements of hand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2.11 ± 0.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47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38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162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8590632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ger taps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2.05 ± 0.7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5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1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83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01887065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 agility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79 ± 0.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4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5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21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67141373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el-knee-shin test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8 ± 0.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32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18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41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8194162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sing from chair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74 ± 1.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6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37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23624387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ur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3 ± 1.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3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179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482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62297370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 sway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2.37 ± 1.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5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57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90981600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it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2.11 ± 1.1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63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3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8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4994936"/>
                  </a:ext>
                </a:extLst>
              </a:tr>
            </a:tbl>
          </a:graphicData>
        </a:graphic>
      </p:graphicFrame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3D6C6AAB-A175-79CC-CE13-74DBB12613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475350"/>
              </p:ext>
            </p:extLst>
          </p:nvPr>
        </p:nvGraphicFramePr>
        <p:xfrm>
          <a:off x="27478" y="461352"/>
          <a:ext cx="5856065" cy="57058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88090">
                  <a:extLst>
                    <a:ext uri="{9D8B030D-6E8A-4147-A177-3AD203B41FA5}">
                      <a16:colId xmlns:a16="http://schemas.microsoft.com/office/drawing/2014/main" val="2857420261"/>
                    </a:ext>
                  </a:extLst>
                </a:gridCol>
                <a:gridCol w="2551647">
                  <a:extLst>
                    <a:ext uri="{9D8B030D-6E8A-4147-A177-3AD203B41FA5}">
                      <a16:colId xmlns:a16="http://schemas.microsoft.com/office/drawing/2014/main" val="3284459849"/>
                    </a:ext>
                  </a:extLst>
                </a:gridCol>
                <a:gridCol w="1005443">
                  <a:extLst>
                    <a:ext uri="{9D8B030D-6E8A-4147-A177-3AD203B41FA5}">
                      <a16:colId xmlns:a16="http://schemas.microsoft.com/office/drawing/2014/main" val="75158859"/>
                    </a:ext>
                  </a:extLst>
                </a:gridCol>
                <a:gridCol w="633056">
                  <a:extLst>
                    <a:ext uri="{9D8B030D-6E8A-4147-A177-3AD203B41FA5}">
                      <a16:colId xmlns:a16="http://schemas.microsoft.com/office/drawing/2014/main" val="1944996675"/>
                    </a:ext>
                  </a:extLst>
                </a:gridCol>
                <a:gridCol w="633056">
                  <a:extLst>
                    <a:ext uri="{9D8B030D-6E8A-4147-A177-3AD203B41FA5}">
                      <a16:colId xmlns:a16="http://schemas.microsoft.com/office/drawing/2014/main" val="138709168"/>
                    </a:ext>
                  </a:extLst>
                </a:gridCol>
                <a:gridCol w="744773">
                  <a:extLst>
                    <a:ext uri="{9D8B030D-6E8A-4147-A177-3AD203B41FA5}">
                      <a16:colId xmlns:a16="http://schemas.microsoft.com/office/drawing/2014/main" val="817994924"/>
                    </a:ext>
                  </a:extLst>
                </a:gridCol>
              </a:tblGrid>
              <a:tr h="438909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MSARS Part 1</a:t>
                      </a:r>
                      <a:endParaRPr lang="en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 </a:t>
                      </a:r>
                    </a:p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q-value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1982535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21 ± 0.7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05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827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36</a:t>
                      </a:r>
                    </a:p>
                  </a:txBody>
                  <a:tcPr marL="4763" marR="4763" marT="47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23321594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wallow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84 ± 0.8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6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1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3</a:t>
                      </a: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674116379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writ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42 ± 1.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3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9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317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90907009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tting food and handling utensil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37 ± 0.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5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1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8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71384408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ess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8 ± 1.3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6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2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1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619237065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gien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8 ± 1.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5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23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11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16659615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lk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2.05 ± 1.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7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195736658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l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2 ± 1.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5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1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78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105759322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thostatic symptom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8 ± 1.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7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8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519867750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ary funct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84 ± 1.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7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0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3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07444356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ual function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2.37 ± 1.74</a:t>
                      </a: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025</a:t>
                      </a: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9205</a:t>
                      </a: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354</a:t>
                      </a:r>
                    </a:p>
                  </a:txBody>
                  <a:tcPr marL="6350" marR="6350" marT="6350" marB="0" anchor="ctr"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3700713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wel funct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79 ± 1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-0.5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01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8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5939155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F106DBA-857E-ED6F-10DF-0399D7E3FAE1}"/>
              </a:ext>
            </a:extLst>
          </p:cNvPr>
          <p:cNvSpPr txBox="1"/>
          <p:nvPr/>
        </p:nvSpPr>
        <p:spPr>
          <a:xfrm>
            <a:off x="27478" y="13089"/>
            <a:ext cx="12137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: Correlations between DSS and clinical indices using Spearman rank correlation coefficient and FDR correction in MSA-P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BC9CFF1-6F38-9BF8-3E22-CD7398A2786C}"/>
              </a:ext>
            </a:extLst>
          </p:cNvPr>
          <p:cNvSpPr txBox="1"/>
          <p:nvPr/>
        </p:nvSpPr>
        <p:spPr>
          <a:xfrm>
            <a:off x="572352" y="6248261"/>
            <a:ext cx="10951041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bbreviations: DSS, dysphagia severity scale; FDR, false discovery rate; MSA, multiple system atrophy; UMSARS, unified MSA rating scale.</a:t>
            </a:r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6030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AA1A57-2586-F666-D8DB-2C968DF32C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B106B334-4E31-B1DF-FCB1-3440938E05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3875299"/>
              </p:ext>
            </p:extLst>
          </p:nvPr>
        </p:nvGraphicFramePr>
        <p:xfrm>
          <a:off x="6047874" y="455052"/>
          <a:ext cx="6116648" cy="570581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63715">
                  <a:extLst>
                    <a:ext uri="{9D8B030D-6E8A-4147-A177-3AD203B41FA5}">
                      <a16:colId xmlns:a16="http://schemas.microsoft.com/office/drawing/2014/main" val="1592536099"/>
                    </a:ext>
                  </a:extLst>
                </a:gridCol>
                <a:gridCol w="2825512">
                  <a:extLst>
                    <a:ext uri="{9D8B030D-6E8A-4147-A177-3AD203B41FA5}">
                      <a16:colId xmlns:a16="http://schemas.microsoft.com/office/drawing/2014/main" val="1442593285"/>
                    </a:ext>
                  </a:extLst>
                </a:gridCol>
                <a:gridCol w="1033754">
                  <a:extLst>
                    <a:ext uri="{9D8B030D-6E8A-4147-A177-3AD203B41FA5}">
                      <a16:colId xmlns:a16="http://schemas.microsoft.com/office/drawing/2014/main" val="1841938356"/>
                    </a:ext>
                  </a:extLst>
                </a:gridCol>
                <a:gridCol w="627636">
                  <a:extLst>
                    <a:ext uri="{9D8B030D-6E8A-4147-A177-3AD203B41FA5}">
                      <a16:colId xmlns:a16="http://schemas.microsoft.com/office/drawing/2014/main" val="1469758428"/>
                    </a:ext>
                  </a:extLst>
                </a:gridCol>
                <a:gridCol w="627636">
                  <a:extLst>
                    <a:ext uri="{9D8B030D-6E8A-4147-A177-3AD203B41FA5}">
                      <a16:colId xmlns:a16="http://schemas.microsoft.com/office/drawing/2014/main" val="3231180097"/>
                    </a:ext>
                  </a:extLst>
                </a:gridCol>
                <a:gridCol w="738395">
                  <a:extLst>
                    <a:ext uri="{9D8B030D-6E8A-4147-A177-3AD203B41FA5}">
                      <a16:colId xmlns:a16="http://schemas.microsoft.com/office/drawing/2014/main" val="823368956"/>
                    </a:ext>
                  </a:extLst>
                </a:gridCol>
              </a:tblGrid>
              <a:tr h="43856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MSARS Part 2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 </a:t>
                      </a:r>
                    </a:p>
                    <a:p>
                      <a:pPr algn="ctr" fontAlgn="b"/>
                      <a:r>
                        <a:rPr lang="en" sz="1200" b="0" u="none" strike="noStrike" dirty="0">
                          <a:ln>
                            <a:noFill/>
                          </a:ln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q-value)</a:t>
                      </a:r>
                      <a:endParaRPr lang="en" sz="1200" b="0" i="0" u="none" strike="noStrike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6182556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ial express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42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1.2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747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&lt;.0001 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&lt;.000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392265558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63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9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488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155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3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16839510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ular motor dysfunct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4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8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068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7524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28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79886662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or at rest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46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9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3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9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6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802341194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on tremor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17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1.1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1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15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8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82759529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reased ton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0.79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9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48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154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36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142751687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pid alternating movements of hand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4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9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476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187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8590632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ger taps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0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88 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43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329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38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01887065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 agility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63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8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596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21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10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67141373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el-knee-shin test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88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0.9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1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13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8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8194162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sing from chair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54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1.6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5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5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4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23624387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ur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08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1.1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728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1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&lt;.000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62297370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 sway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1.92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1.3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54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56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2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90981600"/>
                  </a:ext>
                </a:extLst>
              </a:tr>
              <a:tr h="37623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it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2.33</a:t>
                      </a: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± 1.2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729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1 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&lt;.0001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4994936"/>
                  </a:ext>
                </a:extLst>
              </a:tr>
            </a:tbl>
          </a:graphicData>
        </a:graphic>
      </p:graphicFrame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126AE70A-CE98-79EC-3DEE-DFCD314F60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7894110"/>
              </p:ext>
            </p:extLst>
          </p:nvPr>
        </p:nvGraphicFramePr>
        <p:xfrm>
          <a:off x="27478" y="461352"/>
          <a:ext cx="5856065" cy="57058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88090">
                  <a:extLst>
                    <a:ext uri="{9D8B030D-6E8A-4147-A177-3AD203B41FA5}">
                      <a16:colId xmlns:a16="http://schemas.microsoft.com/office/drawing/2014/main" val="2857420261"/>
                    </a:ext>
                  </a:extLst>
                </a:gridCol>
                <a:gridCol w="2551647">
                  <a:extLst>
                    <a:ext uri="{9D8B030D-6E8A-4147-A177-3AD203B41FA5}">
                      <a16:colId xmlns:a16="http://schemas.microsoft.com/office/drawing/2014/main" val="3284459849"/>
                    </a:ext>
                  </a:extLst>
                </a:gridCol>
                <a:gridCol w="1005443">
                  <a:extLst>
                    <a:ext uri="{9D8B030D-6E8A-4147-A177-3AD203B41FA5}">
                      <a16:colId xmlns:a16="http://schemas.microsoft.com/office/drawing/2014/main" val="75158859"/>
                    </a:ext>
                  </a:extLst>
                </a:gridCol>
                <a:gridCol w="633056">
                  <a:extLst>
                    <a:ext uri="{9D8B030D-6E8A-4147-A177-3AD203B41FA5}">
                      <a16:colId xmlns:a16="http://schemas.microsoft.com/office/drawing/2014/main" val="1944996675"/>
                    </a:ext>
                  </a:extLst>
                </a:gridCol>
                <a:gridCol w="633056">
                  <a:extLst>
                    <a:ext uri="{9D8B030D-6E8A-4147-A177-3AD203B41FA5}">
                      <a16:colId xmlns:a16="http://schemas.microsoft.com/office/drawing/2014/main" val="138709168"/>
                    </a:ext>
                  </a:extLst>
                </a:gridCol>
                <a:gridCol w="744773">
                  <a:extLst>
                    <a:ext uri="{9D8B030D-6E8A-4147-A177-3AD203B41FA5}">
                      <a16:colId xmlns:a16="http://schemas.microsoft.com/office/drawing/2014/main" val="817994924"/>
                    </a:ext>
                  </a:extLst>
                </a:gridCol>
              </a:tblGrid>
              <a:tr h="438909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MSARS Part 1</a:t>
                      </a:r>
                      <a:endParaRPr lang="en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D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 </a:t>
                      </a:r>
                    </a:p>
                    <a:p>
                      <a:pPr algn="ctr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q-value)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1982535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50 ± 0.93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544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60 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3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23321594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wallow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04 ± 1.08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4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7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5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674116379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writ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58 ± 1.18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56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43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18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90907009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tting food and handling utensil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38 ± 1.24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786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0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&lt;.000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71384408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ess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30 ± 1.33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1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15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8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619237065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gien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42 ± 1.38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3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9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6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16659615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lk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.21 ± 1.25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72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1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195736658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ling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42 ± 1.47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51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98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6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105759322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thostatic symptoms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38 ± 1.41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1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15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9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519867750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ary funct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50 ± 1.35</a:t>
                      </a:r>
                    </a:p>
                  </a:txBody>
                  <a:tcPr marL="25400" marR="2540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69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02 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0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07444356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ual function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.63 ± 1.91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408</a:t>
                      </a:r>
                    </a:p>
                  </a:txBody>
                  <a:tcPr marL="6350" marR="6350" marT="6350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481 </a:t>
                      </a:r>
                    </a:p>
                  </a:txBody>
                  <a:tcPr marL="6350" marR="6350" marT="6350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37</a:t>
                      </a:r>
                    </a:p>
                  </a:txBody>
                  <a:tcPr marL="6350" marR="6350" marT="6350" marB="0" anchor="ctr"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3700713"/>
                  </a:ext>
                </a:extLst>
              </a:tr>
              <a:tr h="43890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wel funct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83 ± 1.0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25400" marR="254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-0.52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0.00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5939155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19A7F4-EDBB-5CDD-CEFA-3362F8DCD1D1}"/>
              </a:ext>
            </a:extLst>
          </p:cNvPr>
          <p:cNvSpPr txBox="1"/>
          <p:nvPr/>
        </p:nvSpPr>
        <p:spPr>
          <a:xfrm>
            <a:off x="27478" y="13089"/>
            <a:ext cx="12137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: Correlations between DSS and clinical indices using Spearman rank correlation coefficient and FDR correction in MSA-C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51E2495-A3C3-DBF0-BD09-FB594C9FA5B3}"/>
              </a:ext>
            </a:extLst>
          </p:cNvPr>
          <p:cNvSpPr txBox="1"/>
          <p:nvPr/>
        </p:nvSpPr>
        <p:spPr>
          <a:xfrm>
            <a:off x="572352" y="6248261"/>
            <a:ext cx="10951041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bbreviations: DSS, dysphagia severity scale; FDR, false discovery rate; MSA, multiple system atrophy; UMSARS, unified MSA rating scale.</a:t>
            </a:r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773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489</TotalTime>
  <Words>670</Words>
  <Application>Microsoft Office PowerPoint</Application>
  <PresentationFormat>ワイド画面</PresentationFormat>
  <Paragraphs>342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長尾龍之介</dc:creator>
  <cp:lastModifiedBy>長尾龍之介</cp:lastModifiedBy>
  <cp:revision>41</cp:revision>
  <dcterms:created xsi:type="dcterms:W3CDTF">2024-10-15T11:56:49Z</dcterms:created>
  <dcterms:modified xsi:type="dcterms:W3CDTF">2025-02-24T12:52:04Z</dcterms:modified>
</cp:coreProperties>
</file>